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692647-EE56-4492-84E1-9BDA9D9313A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1679DB-771B-465F-809B-723B975CC9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BC8865-44AA-491A-9BE4-83198734B49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D090B1-FD1B-49C3-8A24-559CE8887F3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3E9C5F-32A4-4F09-B952-7AB19291B7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9F2A05-FF10-4A4C-95FA-59C0093A6A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28635E-50D8-4429-B73F-3E34D4EA1E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B38E87-9599-4DC6-81BA-61B7088CE2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6CCEC6-0B87-44A5-A036-82D6533DE2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8638BA-C39A-48A7-AD97-CE9E0141E3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6E8BFE-942F-478D-B7CE-2B9D808676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04EE45-68D3-4971-902A-EF98CF2945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3CF4A51-F17B-4C5E-AA5C-279A2EB8B4BD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57200" y="3809880"/>
            <a:ext cx="82296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Times New Roman"/>
              </a:rPr>
              <a:t>Figure S2</a:t>
            </a:r>
            <a:r>
              <a:rPr b="0" lang="zh-CN" sz="4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800" spc="-1" strike="noStrike">
                <a:solidFill>
                  <a:srgbClr val="000000"/>
                </a:solidFill>
                <a:latin typeface="Times New Roman"/>
              </a:rPr>
              <a:t>NFκBIA 2758A&gt;G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 genotyping by direct sequencing:     (a) </a:t>
            </a:r>
            <a:r>
              <a:rPr b="0" i="1" lang="zh-CN" sz="1800" spc="-1" strike="noStrike">
                <a:solidFill>
                  <a:srgbClr val="000000"/>
                </a:solidFill>
                <a:latin typeface="Times New Roman"/>
              </a:rPr>
              <a:t>GG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 genotype; (b) </a:t>
            </a:r>
            <a:r>
              <a:rPr b="0" i="1" lang="zh-CN" sz="1800" spc="-1" strike="noStrike">
                <a:solidFill>
                  <a:srgbClr val="000000"/>
                </a:solidFill>
                <a:latin typeface="Times New Roman"/>
              </a:rPr>
              <a:t>AA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 genotype; (c) </a:t>
            </a:r>
            <a:r>
              <a:rPr b="0" i="1" lang="zh-CN" sz="1800" spc="-1" strike="noStrike">
                <a:solidFill>
                  <a:srgbClr val="000000"/>
                </a:solidFill>
                <a:latin typeface="Times New Roman"/>
              </a:rPr>
              <a:t>AG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 genotype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685800" y="228600"/>
            <a:ext cx="7391520" cy="3205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雨林木风</cp:lastModifiedBy>
  <dcterms:modified xsi:type="dcterms:W3CDTF">2011-06-12T15:46:46Z</dcterms:modified>
  <cp:revision>2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